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680" r:id="rId2"/>
    <p:sldId id="686" r:id="rId3"/>
    <p:sldId id="688" r:id="rId4"/>
    <p:sldId id="68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9966156-CB00-7FA5-48DE-0D5B2C08E9EB}" name="Wang,Ziyi" initials="W" userId="S::ZWang31@mdanderson.org::b0343c1d-96c6-4440-ae6c-4107ce351b10" providerId="AD"/>
  <p188:author id="{FD684172-F388-FD6C-688F-E1F07511BC97}" name="Wang,Ziyi" initials="Wa" userId="S::zwang31@mdanderson.org::b0343c1d-96c6-4440-ae6c-4107ce351b10" providerId="AD"/>
  <p188:author id="{AD841EC2-C7AD-60E3-7E13-5A3C566A997C}" name="rluo5@uci.edu" initials="rl" userId="S::urn:spo:guest#rluo5@uci.edu::" providerId="AD"/>
  <p188:author id="{FD74D3C4-253E-9D7C-8418-38A1C06FB9AB}" name="jdou@uab.edu" initials="jd" userId="S::urn:spo:guest#jdou@uab.edu::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1B8E224-C973-44BD-BEEC-3081DFB93638}" v="18" dt="2026-05-19T02:49:38.401"/>
    <p1510:client id="{CF678982-AF7C-6DAF-2556-5F364CE1DBB0}" v="158" dt="2026-05-18T15:25:53.509"/>
    <p1510:client id="{D0A64835-BDE0-E6B1-0054-3562DCFC3359}" v="64" dt="2026-05-18T21:33:23.58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492"/>
    <p:restoredTop sz="78662"/>
  </p:normalViewPr>
  <p:slideViewPr>
    <p:cSldViewPr snapToGrid="0">
      <p:cViewPr varScale="1">
        <p:scale>
          <a:sx n="95" d="100"/>
          <a:sy n="95" d="100"/>
        </p:scale>
        <p:origin x="12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ng,Ziyi" userId="S::zwang31@mdanderson.org::b0343c1d-96c6-4440-ae6c-4107ce351b10" providerId="AD" clId="Web-{D0A64835-BDE0-E6B1-0054-3562DCFC3359}"/>
    <pc:docChg chg="modSld">
      <pc:chgData name="Wang,Ziyi" userId="S::zwang31@mdanderson.org::b0343c1d-96c6-4440-ae6c-4107ce351b10" providerId="AD" clId="Web-{D0A64835-BDE0-E6B1-0054-3562DCFC3359}" dt="2026-05-18T21:33:23.588" v="129" actId="1076"/>
      <pc:docMkLst>
        <pc:docMk/>
      </pc:docMkLst>
      <pc:sldChg chg="addSp delSp modSp modNotes">
        <pc:chgData name="Wang,Ziyi" userId="S::zwang31@mdanderson.org::b0343c1d-96c6-4440-ae6c-4107ce351b10" providerId="AD" clId="Web-{D0A64835-BDE0-E6B1-0054-3562DCFC3359}" dt="2026-05-18T21:33:23.588" v="129" actId="1076"/>
        <pc:sldMkLst>
          <pc:docMk/>
          <pc:sldMk cId="1913821509" sldId="672"/>
        </pc:sldMkLst>
        <pc:picChg chg="add mod ord">
          <ac:chgData name="Wang,Ziyi" userId="S::zwang31@mdanderson.org::b0343c1d-96c6-4440-ae6c-4107ce351b10" providerId="AD" clId="Web-{D0A64835-BDE0-E6B1-0054-3562DCFC3359}" dt="2026-05-18T21:32:14.869" v="118"/>
          <ac:picMkLst>
            <pc:docMk/>
            <pc:sldMk cId="1913821509" sldId="672"/>
            <ac:picMk id="4" creationId="{5FEB37C3-8E97-BB1F-9E56-8F183763B6C6}"/>
          </ac:picMkLst>
        </pc:picChg>
        <pc:picChg chg="add del mod">
          <ac:chgData name="Wang,Ziyi" userId="S::zwang31@mdanderson.org::b0343c1d-96c6-4440-ae6c-4107ce351b10" providerId="AD" clId="Web-{D0A64835-BDE0-E6B1-0054-3562DCFC3359}" dt="2026-05-18T18:13:52.735" v="18"/>
          <ac:picMkLst>
            <pc:docMk/>
            <pc:sldMk cId="1913821509" sldId="672"/>
            <ac:picMk id="4" creationId="{9413B299-2C97-9F03-97EF-A753E97D9B93}"/>
          </ac:picMkLst>
        </pc:picChg>
        <pc:picChg chg="add mod ord">
          <ac:chgData name="Wang,Ziyi" userId="S::zwang31@mdanderson.org::b0343c1d-96c6-4440-ae6c-4107ce351b10" providerId="AD" clId="Web-{D0A64835-BDE0-E6B1-0054-3562DCFC3359}" dt="2026-05-18T21:33:23.588" v="129" actId="1076"/>
          <ac:picMkLst>
            <pc:docMk/>
            <pc:sldMk cId="1913821509" sldId="672"/>
            <ac:picMk id="5" creationId="{4FA2B07F-5CD5-6B26-C0A3-188E1DCCFE39}"/>
          </ac:picMkLst>
        </pc:picChg>
        <pc:picChg chg="add del mod ord">
          <ac:chgData name="Wang,Ziyi" userId="S::zwang31@mdanderson.org::b0343c1d-96c6-4440-ae6c-4107ce351b10" providerId="AD" clId="Web-{D0A64835-BDE0-E6B1-0054-3562DCFC3359}" dt="2026-05-18T21:06:53.600" v="110"/>
          <ac:picMkLst>
            <pc:docMk/>
            <pc:sldMk cId="1913821509" sldId="672"/>
            <ac:picMk id="5" creationId="{6A7400E6-FCF0-89B6-AC62-8597F78772BA}"/>
          </ac:picMkLst>
        </pc:picChg>
        <pc:picChg chg="del">
          <ac:chgData name="Wang,Ziyi" userId="S::zwang31@mdanderson.org::b0343c1d-96c6-4440-ae6c-4107ce351b10" providerId="AD" clId="Web-{D0A64835-BDE0-E6B1-0054-3562DCFC3359}" dt="2026-05-18T18:12:11.107" v="13"/>
          <ac:picMkLst>
            <pc:docMk/>
            <pc:sldMk cId="1913821509" sldId="672"/>
            <ac:picMk id="7" creationId="{76AC6B9A-EDD0-F7F0-DB90-F8C27B4E0002}"/>
          </ac:picMkLst>
        </pc:picChg>
        <pc:picChg chg="del">
          <ac:chgData name="Wang,Ziyi" userId="S::zwang31@mdanderson.org::b0343c1d-96c6-4440-ae6c-4107ce351b10" providerId="AD" clId="Web-{D0A64835-BDE0-E6B1-0054-3562DCFC3359}" dt="2026-05-18T18:12:12.357" v="14"/>
          <ac:picMkLst>
            <pc:docMk/>
            <pc:sldMk cId="1913821509" sldId="672"/>
            <ac:picMk id="8" creationId="{2C54C6CB-CB11-764B-CB67-C24B85544E37}"/>
          </ac:picMkLst>
        </pc:picChg>
        <pc:picChg chg="add del mod ord">
          <ac:chgData name="Wang,Ziyi" userId="S::zwang31@mdanderson.org::b0343c1d-96c6-4440-ae6c-4107ce351b10" providerId="AD" clId="Web-{D0A64835-BDE0-E6B1-0054-3562DCFC3359}" dt="2026-05-18T18:15:55.973" v="85"/>
          <ac:picMkLst>
            <pc:docMk/>
            <pc:sldMk cId="1913821509" sldId="672"/>
            <ac:picMk id="9" creationId="{3D32D74C-1D9A-5BC4-1D36-8C3D218C60B7}"/>
          </ac:picMkLst>
        </pc:picChg>
        <pc:picChg chg="add del mod ord">
          <ac:chgData name="Wang,Ziyi" userId="S::zwang31@mdanderson.org::b0343c1d-96c6-4440-ae6c-4107ce351b10" providerId="AD" clId="Web-{D0A64835-BDE0-E6B1-0054-3562DCFC3359}" dt="2026-05-18T21:06:55.131" v="111"/>
          <ac:picMkLst>
            <pc:docMk/>
            <pc:sldMk cId="1913821509" sldId="672"/>
            <ac:picMk id="10" creationId="{0F0C4C18-657A-D563-91B4-6C65A67C09F1}"/>
          </ac:picMkLst>
        </pc:picChg>
      </pc:sldChg>
      <pc:sldChg chg="modNotes">
        <pc:chgData name="Wang,Ziyi" userId="S::zwang31@mdanderson.org::b0343c1d-96c6-4440-ae6c-4107ce351b10" providerId="AD" clId="Web-{D0A64835-BDE0-E6B1-0054-3562DCFC3359}" dt="2026-05-18T18:17:08.163" v="96"/>
        <pc:sldMkLst>
          <pc:docMk/>
          <pc:sldMk cId="1059176776" sldId="687"/>
        </pc:sldMkLst>
      </pc:sldChg>
      <pc:sldChg chg="modSp modNotes">
        <pc:chgData name="Wang,Ziyi" userId="S::zwang31@mdanderson.org::b0343c1d-96c6-4440-ae6c-4107ce351b10" providerId="AD" clId="Web-{D0A64835-BDE0-E6B1-0054-3562DCFC3359}" dt="2026-05-18T18:17:16.116" v="103"/>
        <pc:sldMkLst>
          <pc:docMk/>
          <pc:sldMk cId="2851574" sldId="688"/>
        </pc:sldMkLst>
        <pc:picChg chg="mod">
          <ac:chgData name="Wang,Ziyi" userId="S::zwang31@mdanderson.org::b0343c1d-96c6-4440-ae6c-4107ce351b10" providerId="AD" clId="Web-{D0A64835-BDE0-E6B1-0054-3562DCFC3359}" dt="2026-05-18T17:12:17.341" v="12" actId="14100"/>
          <ac:picMkLst>
            <pc:docMk/>
            <pc:sldMk cId="2851574" sldId="688"/>
            <ac:picMk id="7" creationId="{50503C12-9F1F-5090-E4F0-BA35214B6E42}"/>
          </ac:picMkLst>
        </pc:picChg>
        <pc:picChg chg="mod">
          <ac:chgData name="Wang,Ziyi" userId="S::zwang31@mdanderson.org::b0343c1d-96c6-4440-ae6c-4107ce351b10" providerId="AD" clId="Web-{D0A64835-BDE0-E6B1-0054-3562DCFC3359}" dt="2026-05-18T17:12:12.029" v="11" actId="14100"/>
          <ac:picMkLst>
            <pc:docMk/>
            <pc:sldMk cId="2851574" sldId="688"/>
            <ac:picMk id="9" creationId="{8F21A4E5-F3A1-2F9F-0FBC-9B2FE057486C}"/>
          </ac:picMkLst>
        </pc:picChg>
      </pc:sldChg>
      <pc:sldChg chg="modNotes">
        <pc:chgData name="Wang,Ziyi" userId="S::zwang31@mdanderson.org::b0343c1d-96c6-4440-ae6c-4107ce351b10" providerId="AD" clId="Web-{D0A64835-BDE0-E6B1-0054-3562DCFC3359}" dt="2026-05-18T18:17:29.616" v="109"/>
        <pc:sldMkLst>
          <pc:docMk/>
          <pc:sldMk cId="4292022454" sldId="689"/>
        </pc:sldMkLst>
      </pc:sldChg>
    </pc:docChg>
  </pc:docChgLst>
  <pc:docChgLst>
    <pc:chgData name="rluo5@uci.edu" userId="S::urn:spo:guest#rluo5@uci.edu::" providerId="AD" clId="Web-{91B8E224-C973-44BD-BEEC-3081DFB93638}"/>
    <pc:docChg chg="modSld">
      <pc:chgData name="rluo5@uci.edu" userId="S::urn:spo:guest#rluo5@uci.edu::" providerId="AD" clId="Web-{91B8E224-C973-44BD-BEEC-3081DFB93638}" dt="2026-05-19T02:49:38.839" v="15"/>
      <pc:docMkLst>
        <pc:docMk/>
      </pc:docMkLst>
      <pc:sldChg chg="modSp">
        <pc:chgData name="rluo5@uci.edu" userId="S::urn:spo:guest#rluo5@uci.edu::" providerId="AD" clId="Web-{91B8E224-C973-44BD-BEEC-3081DFB93638}" dt="2026-05-18T22:37:38.544" v="7" actId="1076"/>
        <pc:sldMkLst>
          <pc:docMk/>
          <pc:sldMk cId="1913821509" sldId="672"/>
        </pc:sldMkLst>
        <pc:spChg chg="mod">
          <ac:chgData name="rluo5@uci.edu" userId="S::urn:spo:guest#rluo5@uci.edu::" providerId="AD" clId="Web-{91B8E224-C973-44BD-BEEC-3081DFB93638}" dt="2026-05-18T22:37:38.544" v="6" actId="1076"/>
          <ac:spMkLst>
            <pc:docMk/>
            <pc:sldMk cId="1913821509" sldId="672"/>
            <ac:spMk id="16" creationId="{F751CCF1-EE44-8C0C-77B4-F6447995426A}"/>
          </ac:spMkLst>
        </pc:spChg>
        <pc:spChg chg="mod">
          <ac:chgData name="rluo5@uci.edu" userId="S::urn:spo:guest#rluo5@uci.edu::" providerId="AD" clId="Web-{91B8E224-C973-44BD-BEEC-3081DFB93638}" dt="2026-05-18T22:37:38.544" v="7" actId="1076"/>
          <ac:spMkLst>
            <pc:docMk/>
            <pc:sldMk cId="1913821509" sldId="672"/>
            <ac:spMk id="17" creationId="{1CD9F533-6D4D-4043-56B9-C850A9243ADA}"/>
          </ac:spMkLst>
        </pc:spChg>
        <pc:picChg chg="mod">
          <ac:chgData name="rluo5@uci.edu" userId="S::urn:spo:guest#rluo5@uci.edu::" providerId="AD" clId="Web-{91B8E224-C973-44BD-BEEC-3081DFB93638}" dt="2026-05-18T22:37:13.731" v="3" actId="1076"/>
          <ac:picMkLst>
            <pc:docMk/>
            <pc:sldMk cId="1913821509" sldId="672"/>
            <ac:picMk id="3" creationId="{1799BEEC-0BF6-3340-7653-ACBCA55849F0}"/>
          </ac:picMkLst>
        </pc:picChg>
        <pc:picChg chg="mod">
          <ac:chgData name="rluo5@uci.edu" userId="S::urn:spo:guest#rluo5@uci.edu::" providerId="AD" clId="Web-{91B8E224-C973-44BD-BEEC-3081DFB93638}" dt="2026-05-18T22:37:30.450" v="5" actId="1076"/>
          <ac:picMkLst>
            <pc:docMk/>
            <pc:sldMk cId="1913821509" sldId="672"/>
            <ac:picMk id="6" creationId="{751F91D4-68AB-B5A8-568D-E341EE27DA79}"/>
          </ac:picMkLst>
        </pc:picChg>
      </pc:sldChg>
      <pc:sldChg chg="modSp modNotes">
        <pc:chgData name="rluo5@uci.edu" userId="S::urn:spo:guest#rluo5@uci.edu::" providerId="AD" clId="Web-{91B8E224-C973-44BD-BEEC-3081DFB93638}" dt="2026-05-19T02:49:35.510" v="12"/>
        <pc:sldMkLst>
          <pc:docMk/>
          <pc:sldMk cId="2851574" sldId="688"/>
        </pc:sldMkLst>
        <pc:spChg chg="mod">
          <ac:chgData name="rluo5@uci.edu" userId="S::urn:spo:guest#rluo5@uci.edu::" providerId="AD" clId="Web-{91B8E224-C973-44BD-BEEC-3081DFB93638}" dt="2026-05-19T02:49:32.885" v="9" actId="20577"/>
          <ac:spMkLst>
            <pc:docMk/>
            <pc:sldMk cId="2851574" sldId="688"/>
            <ac:spMk id="5" creationId="{19971AF9-37B0-D76E-2774-44BB826BB38E}"/>
          </ac:spMkLst>
        </pc:spChg>
      </pc:sldChg>
      <pc:sldChg chg="modSp modNotes">
        <pc:chgData name="rluo5@uci.edu" userId="S::urn:spo:guest#rluo5@uci.edu::" providerId="AD" clId="Web-{91B8E224-C973-44BD-BEEC-3081DFB93638}" dt="2026-05-19T02:49:38.839" v="15"/>
        <pc:sldMkLst>
          <pc:docMk/>
          <pc:sldMk cId="4292022454" sldId="689"/>
        </pc:sldMkLst>
        <pc:spChg chg="mod">
          <ac:chgData name="rluo5@uci.edu" userId="S::urn:spo:guest#rluo5@uci.edu::" providerId="AD" clId="Web-{91B8E224-C973-44BD-BEEC-3081DFB93638}" dt="2026-05-19T02:49:37.854" v="13" actId="20577"/>
          <ac:spMkLst>
            <pc:docMk/>
            <pc:sldMk cId="4292022454" sldId="689"/>
            <ac:spMk id="5" creationId="{87FF8C7A-C7C9-6A47-AB0E-3536E50DDBB0}"/>
          </ac:spMkLst>
        </pc:spChg>
      </pc:sldChg>
    </pc:docChg>
  </pc:docChgLst>
  <pc:docChgLst>
    <pc:chgData name="Wang,Ziyi" userId="S::zwang31@mdanderson.org::b0343c1d-96c6-4440-ae6c-4107ce351b10" providerId="AD" clId="Web-{CF678982-AF7C-6DAF-2556-5F364CE1DBB0}"/>
    <pc:docChg chg="addSld modSld">
      <pc:chgData name="Wang,Ziyi" userId="S::zwang31@mdanderson.org::b0343c1d-96c6-4440-ae6c-4107ce351b10" providerId="AD" clId="Web-{CF678982-AF7C-6DAF-2556-5F364CE1DBB0}" dt="2026-05-18T15:25:53.353" v="543"/>
      <pc:docMkLst>
        <pc:docMk/>
      </pc:docMkLst>
      <pc:sldChg chg="addSp delSp modSp new modNotes">
        <pc:chgData name="Wang,Ziyi" userId="S::zwang31@mdanderson.org::b0343c1d-96c6-4440-ae6c-4107ce351b10" providerId="AD" clId="Web-{CF678982-AF7C-6DAF-2556-5F364CE1DBB0}" dt="2026-05-18T15:25:53.353" v="543"/>
        <pc:sldMkLst>
          <pc:docMk/>
          <pc:sldMk cId="1059176776" sldId="687"/>
        </pc:sldMkLst>
        <pc:spChg chg="del">
          <ac:chgData name="Wang,Ziyi" userId="S::zwang31@mdanderson.org::b0343c1d-96c6-4440-ae6c-4107ce351b10" providerId="AD" clId="Web-{CF678982-AF7C-6DAF-2556-5F364CE1DBB0}" dt="2026-05-18T15:01:40.625" v="3"/>
          <ac:spMkLst>
            <pc:docMk/>
            <pc:sldMk cId="1059176776" sldId="687"/>
            <ac:spMk id="2" creationId="{E26C39CD-D6B6-2C99-EA16-E7D5BD3A93EA}"/>
          </ac:spMkLst>
        </pc:spChg>
        <pc:spChg chg="del">
          <ac:chgData name="Wang,Ziyi" userId="S::zwang31@mdanderson.org::b0343c1d-96c6-4440-ae6c-4107ce351b10" providerId="AD" clId="Web-{CF678982-AF7C-6DAF-2556-5F364CE1DBB0}" dt="2026-05-18T15:01:42.235" v="4"/>
          <ac:spMkLst>
            <pc:docMk/>
            <pc:sldMk cId="1059176776" sldId="687"/>
            <ac:spMk id="3" creationId="{F869EFA2-7C98-37D5-B5B9-5B828CDC6070}"/>
          </ac:spMkLst>
        </pc:spChg>
        <pc:spChg chg="add mod">
          <ac:chgData name="Wang,Ziyi" userId="S::zwang31@mdanderson.org::b0343c1d-96c6-4440-ae6c-4107ce351b10" providerId="AD" clId="Web-{CF678982-AF7C-6DAF-2556-5F364CE1DBB0}" dt="2026-05-18T15:01:36.922" v="2" actId="20577"/>
          <ac:spMkLst>
            <pc:docMk/>
            <pc:sldMk cId="1059176776" sldId="687"/>
            <ac:spMk id="5" creationId="{3881437E-FC50-3C6D-45E6-4C976A9EEB75}"/>
          </ac:spMkLst>
        </pc:spChg>
        <pc:spChg chg="add mod">
          <ac:chgData name="Wang,Ziyi" userId="S::zwang31@mdanderson.org::b0343c1d-96c6-4440-ae6c-4107ce351b10" providerId="AD" clId="Web-{CF678982-AF7C-6DAF-2556-5F364CE1DBB0}" dt="2026-05-18T15:18:54.089" v="346" actId="1076"/>
          <ac:spMkLst>
            <pc:docMk/>
            <pc:sldMk cId="1059176776" sldId="687"/>
            <ac:spMk id="11" creationId="{7DFE0F06-E01B-DAFD-E7F7-FD825A0896CD}"/>
          </ac:spMkLst>
        </pc:spChg>
        <pc:spChg chg="add mod">
          <ac:chgData name="Wang,Ziyi" userId="S::zwang31@mdanderson.org::b0343c1d-96c6-4440-ae6c-4107ce351b10" providerId="AD" clId="Web-{CF678982-AF7C-6DAF-2556-5F364CE1DBB0}" dt="2026-05-18T15:18:54.089" v="347" actId="1076"/>
          <ac:spMkLst>
            <pc:docMk/>
            <pc:sldMk cId="1059176776" sldId="687"/>
            <ac:spMk id="13" creationId="{71C81699-088D-C44D-6CC4-3EC9BDEBFA34}"/>
          </ac:spMkLst>
        </pc:spChg>
        <pc:spChg chg="add mod">
          <ac:chgData name="Wang,Ziyi" userId="S::zwang31@mdanderson.org::b0343c1d-96c6-4440-ae6c-4107ce351b10" providerId="AD" clId="Web-{CF678982-AF7C-6DAF-2556-5F364CE1DBB0}" dt="2026-05-18T15:18:54.089" v="348" actId="1076"/>
          <ac:spMkLst>
            <pc:docMk/>
            <pc:sldMk cId="1059176776" sldId="687"/>
            <ac:spMk id="15" creationId="{B3379DEA-749A-513C-697D-1454262A726A}"/>
          </ac:spMkLst>
        </pc:spChg>
        <pc:spChg chg="add mod">
          <ac:chgData name="Wang,Ziyi" userId="S::zwang31@mdanderson.org::b0343c1d-96c6-4440-ae6c-4107ce351b10" providerId="AD" clId="Web-{CF678982-AF7C-6DAF-2556-5F364CE1DBB0}" dt="2026-05-18T15:18:54.105" v="349" actId="1076"/>
          <ac:spMkLst>
            <pc:docMk/>
            <pc:sldMk cId="1059176776" sldId="687"/>
            <ac:spMk id="17" creationId="{8D44091C-0814-0CF5-9198-34AED591B679}"/>
          </ac:spMkLst>
        </pc:spChg>
        <pc:picChg chg="add mod">
          <ac:chgData name="Wang,Ziyi" userId="S::zwang31@mdanderson.org::b0343c1d-96c6-4440-ae6c-4107ce351b10" providerId="AD" clId="Web-{CF678982-AF7C-6DAF-2556-5F364CE1DBB0}" dt="2026-05-18T15:19:00.261" v="350" actId="1076"/>
          <ac:picMkLst>
            <pc:docMk/>
            <pc:sldMk cId="1059176776" sldId="687"/>
            <ac:picMk id="6" creationId="{C327DAD3-85AF-D4AB-F595-AA87FAD8BE81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21:03.885" v="443" actId="1076"/>
          <ac:picMkLst>
            <pc:docMk/>
            <pc:sldMk cId="1059176776" sldId="687"/>
            <ac:picMk id="7" creationId="{361AE2D2-300C-8F16-BB5F-6FAF4F7A133D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21:07.542" v="444" actId="1076"/>
          <ac:picMkLst>
            <pc:docMk/>
            <pc:sldMk cId="1059176776" sldId="687"/>
            <ac:picMk id="8" creationId="{D6CD716E-55DB-105B-0CA3-AD78CFDB5163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19:02.917" v="355" actId="1076"/>
          <ac:picMkLst>
            <pc:docMk/>
            <pc:sldMk cId="1059176776" sldId="687"/>
            <ac:picMk id="9" creationId="{F142E5CB-C1CE-B613-322D-B3A5660836B4}"/>
          </ac:picMkLst>
        </pc:picChg>
      </pc:sldChg>
      <pc:sldChg chg="addSp delSp modSp new modNotes">
        <pc:chgData name="Wang,Ziyi" userId="S::zwang31@mdanderson.org::b0343c1d-96c6-4440-ae6c-4107ce351b10" providerId="AD" clId="Web-{CF678982-AF7C-6DAF-2556-5F364CE1DBB0}" dt="2026-05-18T15:25:17.181" v="533"/>
        <pc:sldMkLst>
          <pc:docMk/>
          <pc:sldMk cId="2851574" sldId="688"/>
        </pc:sldMkLst>
        <pc:spChg chg="del">
          <ac:chgData name="Wang,Ziyi" userId="S::zwang31@mdanderson.org::b0343c1d-96c6-4440-ae6c-4107ce351b10" providerId="AD" clId="Web-{CF678982-AF7C-6DAF-2556-5F364CE1DBB0}" dt="2026-05-18T15:06:57.859" v="12"/>
          <ac:spMkLst>
            <pc:docMk/>
            <pc:sldMk cId="2851574" sldId="688"/>
            <ac:spMk id="2" creationId="{42520000-BA8A-767C-5CFF-9C6B10698ADA}"/>
          </ac:spMkLst>
        </pc:spChg>
        <pc:spChg chg="del">
          <ac:chgData name="Wang,Ziyi" userId="S::zwang31@mdanderson.org::b0343c1d-96c6-4440-ae6c-4107ce351b10" providerId="AD" clId="Web-{CF678982-AF7C-6DAF-2556-5F364CE1DBB0}" dt="2026-05-18T15:06:59.218" v="13"/>
          <ac:spMkLst>
            <pc:docMk/>
            <pc:sldMk cId="2851574" sldId="688"/>
            <ac:spMk id="3" creationId="{6BA11FAE-1873-DC63-9BDC-0B12A6E43531}"/>
          </ac:spMkLst>
        </pc:spChg>
        <pc:spChg chg="add mod">
          <ac:chgData name="Wang,Ziyi" userId="S::zwang31@mdanderson.org::b0343c1d-96c6-4440-ae6c-4107ce351b10" providerId="AD" clId="Web-{CF678982-AF7C-6DAF-2556-5F364CE1DBB0}" dt="2026-05-18T15:06:55.171" v="11" actId="20577"/>
          <ac:spMkLst>
            <pc:docMk/>
            <pc:sldMk cId="2851574" sldId="688"/>
            <ac:spMk id="5" creationId="{19971AF9-37B0-D76E-2774-44BB826BB38E}"/>
          </ac:spMkLst>
        </pc:spChg>
        <pc:spChg chg="add mod">
          <ac:chgData name="Wang,Ziyi" userId="S::zwang31@mdanderson.org::b0343c1d-96c6-4440-ae6c-4107ce351b10" providerId="AD" clId="Web-{CF678982-AF7C-6DAF-2556-5F364CE1DBB0}" dt="2026-05-18T15:10:15.482" v="116" actId="1076"/>
          <ac:spMkLst>
            <pc:docMk/>
            <pc:sldMk cId="2851574" sldId="688"/>
            <ac:spMk id="11" creationId="{6C8136BD-106F-D484-28C8-F5B1B4FB5A37}"/>
          </ac:spMkLst>
        </pc:spChg>
        <pc:spChg chg="add mod">
          <ac:chgData name="Wang,Ziyi" userId="S::zwang31@mdanderson.org::b0343c1d-96c6-4440-ae6c-4107ce351b10" providerId="AD" clId="Web-{CF678982-AF7C-6DAF-2556-5F364CE1DBB0}" dt="2026-05-18T15:10:28.716" v="124" actId="1076"/>
          <ac:spMkLst>
            <pc:docMk/>
            <pc:sldMk cId="2851574" sldId="688"/>
            <ac:spMk id="13" creationId="{014D418F-A49C-5A75-E246-3B0A35C6F53F}"/>
          </ac:spMkLst>
        </pc:spChg>
        <pc:spChg chg="add mod">
          <ac:chgData name="Wang,Ziyi" userId="S::zwang31@mdanderson.org::b0343c1d-96c6-4440-ae6c-4107ce351b10" providerId="AD" clId="Web-{CF678982-AF7C-6DAF-2556-5F364CE1DBB0}" dt="2026-05-18T15:10:45.451" v="132" actId="20577"/>
          <ac:spMkLst>
            <pc:docMk/>
            <pc:sldMk cId="2851574" sldId="688"/>
            <ac:spMk id="14" creationId="{6721EEA1-E6CF-08D5-17FD-688FEC8E6016}"/>
          </ac:spMkLst>
        </pc:spChg>
        <pc:spChg chg="add mod">
          <ac:chgData name="Wang,Ziyi" userId="S::zwang31@mdanderson.org::b0343c1d-96c6-4440-ae6c-4107ce351b10" providerId="AD" clId="Web-{CF678982-AF7C-6DAF-2556-5F364CE1DBB0}" dt="2026-05-18T15:10:42.169" v="130" actId="20577"/>
          <ac:spMkLst>
            <pc:docMk/>
            <pc:sldMk cId="2851574" sldId="688"/>
            <ac:spMk id="15" creationId="{D69D78B4-F786-646D-6732-4973C4B1A9CD}"/>
          </ac:spMkLst>
        </pc:spChg>
        <pc:spChg chg="add del mod">
          <ac:chgData name="Wang,Ziyi" userId="S::zwang31@mdanderson.org::b0343c1d-96c6-4440-ae6c-4107ce351b10" providerId="AD" clId="Web-{CF678982-AF7C-6DAF-2556-5F364CE1DBB0}" dt="2026-05-18T15:14:32.137" v="239"/>
          <ac:spMkLst>
            <pc:docMk/>
            <pc:sldMk cId="2851574" sldId="688"/>
            <ac:spMk id="16" creationId="{42DF76A4-F2E8-2D96-6EBA-755B25E755B3}"/>
          </ac:spMkLst>
        </pc:spChg>
        <pc:picChg chg="add del mod">
          <ac:chgData name="Wang,Ziyi" userId="S::zwang31@mdanderson.org::b0343c1d-96c6-4440-ae6c-4107ce351b10" providerId="AD" clId="Web-{CF678982-AF7C-6DAF-2556-5F364CE1DBB0}" dt="2026-05-18T15:24:00.041" v="469"/>
          <ac:picMkLst>
            <pc:docMk/>
            <pc:sldMk cId="2851574" sldId="688"/>
            <ac:picMk id="6" creationId="{F4CF2782-4D4B-B02C-1749-1F1CBB83DDE9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17:16.589" v="316" actId="1076"/>
          <ac:picMkLst>
            <pc:docMk/>
            <pc:sldMk cId="2851574" sldId="688"/>
            <ac:picMk id="7" creationId="{50503C12-9F1F-5090-E4F0-BA35214B6E42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17:11.496" v="314" actId="1076"/>
          <ac:picMkLst>
            <pc:docMk/>
            <pc:sldMk cId="2851574" sldId="688"/>
            <ac:picMk id="8" creationId="{ACD2F03D-425F-5D16-60CA-9D505587ABA1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10:25.029" v="122" actId="1076"/>
          <ac:picMkLst>
            <pc:docMk/>
            <pc:sldMk cId="2851574" sldId="688"/>
            <ac:picMk id="9" creationId="{8F21A4E5-F3A1-2F9F-0FBC-9B2FE057486C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24:32.400" v="473" actId="14100"/>
          <ac:picMkLst>
            <pc:docMk/>
            <pc:sldMk cId="2851574" sldId="688"/>
            <ac:picMk id="17" creationId="{1B415D17-FD12-4928-2F05-04A0F9E3D88D}"/>
          </ac:picMkLst>
        </pc:picChg>
      </pc:sldChg>
      <pc:sldChg chg="addSp delSp modSp add replId modNotes">
        <pc:chgData name="Wang,Ziyi" userId="S::zwang31@mdanderson.org::b0343c1d-96c6-4440-ae6c-4107ce351b10" providerId="AD" clId="Web-{CF678982-AF7C-6DAF-2556-5F364CE1DBB0}" dt="2026-05-18T15:25:26.134" v="539"/>
        <pc:sldMkLst>
          <pc:docMk/>
          <pc:sldMk cId="4292022454" sldId="689"/>
        </pc:sldMkLst>
        <pc:spChg chg="mod">
          <ac:chgData name="Wang,Ziyi" userId="S::zwang31@mdanderson.org::b0343c1d-96c6-4440-ae6c-4107ce351b10" providerId="AD" clId="Web-{CF678982-AF7C-6DAF-2556-5F364CE1DBB0}" dt="2026-05-18T15:14:38.496" v="241" actId="20577"/>
          <ac:spMkLst>
            <pc:docMk/>
            <pc:sldMk cId="4292022454" sldId="689"/>
            <ac:spMk id="5" creationId="{87FF8C7A-C7C9-6A47-AB0E-3536E50DDBB0}"/>
          </ac:spMkLst>
        </pc:spChg>
        <pc:picChg chg="add mod">
          <ac:chgData name="Wang,Ziyi" userId="S::zwang31@mdanderson.org::b0343c1d-96c6-4440-ae6c-4107ce351b10" providerId="AD" clId="Web-{CF678982-AF7C-6DAF-2556-5F364CE1DBB0}" dt="2026-05-18T15:16:34.246" v="307" actId="1076"/>
          <ac:picMkLst>
            <pc:docMk/>
            <pc:sldMk cId="4292022454" sldId="689"/>
            <ac:picMk id="2" creationId="{89E46C3A-CD58-483B-ADDF-E08395429A85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17:30.355" v="321" actId="14100"/>
          <ac:picMkLst>
            <pc:docMk/>
            <pc:sldMk cId="4292022454" sldId="689"/>
            <ac:picMk id="3" creationId="{FED54664-55AB-2A9B-31C6-8B01910046DC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18:15.855" v="334" actId="14100"/>
          <ac:picMkLst>
            <pc:docMk/>
            <pc:sldMk cId="4292022454" sldId="689"/>
            <ac:picMk id="4" creationId="{71641A64-94D9-1F71-33FF-22594E9E78AD}"/>
          </ac:picMkLst>
        </pc:picChg>
        <pc:picChg chg="del">
          <ac:chgData name="Wang,Ziyi" userId="S::zwang31@mdanderson.org::b0343c1d-96c6-4440-ae6c-4107ce351b10" providerId="AD" clId="Web-{CF678982-AF7C-6DAF-2556-5F364CE1DBB0}" dt="2026-05-18T15:15:27.824" v="292"/>
          <ac:picMkLst>
            <pc:docMk/>
            <pc:sldMk cId="4292022454" sldId="689"/>
            <ac:picMk id="6" creationId="{5F768E70-B99F-B937-B0B8-A681F3F5798A}"/>
          </ac:picMkLst>
        </pc:picChg>
        <pc:picChg chg="del">
          <ac:chgData name="Wang,Ziyi" userId="S::zwang31@mdanderson.org::b0343c1d-96c6-4440-ae6c-4107ce351b10" providerId="AD" clId="Web-{CF678982-AF7C-6DAF-2556-5F364CE1DBB0}" dt="2026-05-18T15:15:28.965" v="295"/>
          <ac:picMkLst>
            <pc:docMk/>
            <pc:sldMk cId="4292022454" sldId="689"/>
            <ac:picMk id="7" creationId="{0C637C59-3D9F-E4BE-E9A5-0D9FD2CA1681}"/>
          </ac:picMkLst>
        </pc:picChg>
        <pc:picChg chg="del">
          <ac:chgData name="Wang,Ziyi" userId="S::zwang31@mdanderson.org::b0343c1d-96c6-4440-ae6c-4107ce351b10" providerId="AD" clId="Web-{CF678982-AF7C-6DAF-2556-5F364CE1DBB0}" dt="2026-05-18T15:15:28.183" v="293"/>
          <ac:picMkLst>
            <pc:docMk/>
            <pc:sldMk cId="4292022454" sldId="689"/>
            <ac:picMk id="8" creationId="{A3E5106C-516D-1D40-B3A3-BA2778DDC97D}"/>
          </ac:picMkLst>
        </pc:picChg>
        <pc:picChg chg="del">
          <ac:chgData name="Wang,Ziyi" userId="S::zwang31@mdanderson.org::b0343c1d-96c6-4440-ae6c-4107ce351b10" providerId="AD" clId="Web-{CF678982-AF7C-6DAF-2556-5F364CE1DBB0}" dt="2026-05-18T15:15:28.699" v="294"/>
          <ac:picMkLst>
            <pc:docMk/>
            <pc:sldMk cId="4292022454" sldId="689"/>
            <ac:picMk id="9" creationId="{2D34A9C7-BAE9-A890-81EE-59B030BC07F5}"/>
          </ac:picMkLst>
        </pc:picChg>
        <pc:picChg chg="add mod">
          <ac:chgData name="Wang,Ziyi" userId="S::zwang31@mdanderson.org::b0343c1d-96c6-4440-ae6c-4107ce351b10" providerId="AD" clId="Web-{CF678982-AF7C-6DAF-2556-5F364CE1DBB0}" dt="2026-05-18T15:18:34.495" v="341" actId="14100"/>
          <ac:picMkLst>
            <pc:docMk/>
            <pc:sldMk cId="4292022454" sldId="689"/>
            <ac:picMk id="10" creationId="{13B0F791-2427-FC56-D800-6CEE4B9F7C58}"/>
          </ac:picMkLst>
        </pc:picChg>
      </pc:sldChg>
    </pc:docChg>
  </pc:docChgLst>
  <pc:docChgLst>
    <pc:chgData name="rluo5@uci.edu" userId="S::urn:spo:guest#rluo5@uci.edu::" providerId="AD" clId="Web-{41951ECD-2946-D1A0-051A-FF9E2B20F561}"/>
    <pc:docChg chg="modSld">
      <pc:chgData name="rluo5@uci.edu" userId="S::urn:spo:guest#rluo5@uci.edu::" providerId="AD" clId="Web-{41951ECD-2946-D1A0-051A-FF9E2B20F561}" dt="2026-05-15T14:16:46.405" v="1"/>
      <pc:docMkLst>
        <pc:docMk/>
      </pc:docMkLst>
      <pc:sldChg chg="modNotes">
        <pc:chgData name="rluo5@uci.edu" userId="S::urn:spo:guest#rluo5@uci.edu::" providerId="AD" clId="Web-{41951ECD-2946-D1A0-051A-FF9E2B20F561}" dt="2026-05-15T14:16:46.405" v="1"/>
        <pc:sldMkLst>
          <pc:docMk/>
          <pc:sldMk cId="1098566561" sldId="67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FE3935-E05B-9043-B91E-C4D54FB2FFC3}" type="datetimeFigureOut">
              <a:rPr lang="en-US" smtClean="0"/>
              <a:t>6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1863C7-5195-9447-9340-D3FD10940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778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0F76DF3-F58A-01A4-B9E3-E720EEFE5D0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FC360576-A937-AC72-25B4-56482E49E7C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59C880E7-A9B9-51F7-B3E0-24FBE23FB5B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N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: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ariant depth features</a:t>
            </a:r>
          </a:p>
          <a:p>
            <a:pPr marL="228600" indent="-228600">
              <a:buAutoNum type="alphaUcPeriod"/>
              <a:defRPr/>
            </a:pPr>
            <a:r>
              <a:rPr lang="en-US"/>
              <a:t>Read depth distribution of all genomic loci detected in snRNA data. </a:t>
            </a:r>
            <a:endParaRPr lang="en-US">
              <a:solidFill>
                <a:srgbClr val="444444"/>
              </a:solidFill>
            </a:endParaRPr>
          </a:p>
          <a:p>
            <a:pPr marL="228600" indent="-228600">
              <a:buAutoNum type="alphaUcPeriod"/>
              <a:defRPr/>
            </a:pPr>
            <a:r>
              <a:rPr lang="en-US"/>
              <a:t>Read depth distribution of all genomic loci detected in </a:t>
            </a:r>
            <a:r>
              <a:rPr lang="en-US" err="1"/>
              <a:t>snATAC</a:t>
            </a:r>
            <a:r>
              <a:rPr lang="en-US"/>
              <a:t> data. </a:t>
            </a:r>
            <a:endParaRPr lang="en-US">
              <a:solidFill>
                <a:srgbClr val="444444"/>
              </a:solidFill>
            </a:endParaRPr>
          </a:p>
          <a:p>
            <a:pPr marL="228600" indent="-228600">
              <a:buFontTx/>
              <a:buAutoNum type="alphaUcPeriod"/>
              <a:defRPr/>
            </a:pPr>
            <a:r>
              <a:rPr lang="en-US"/>
              <a:t>Read depth distribution of all detected loci overlapped with WGS ground truth in snRNA data.</a:t>
            </a:r>
            <a:endParaRPr lang="en-US">
              <a:solidFill>
                <a:srgbClr val="444444"/>
              </a:solidFill>
            </a:endParaRPr>
          </a:p>
          <a:p>
            <a:pPr marL="228600" indent="-228600">
              <a:buAutoNum type="alphaUcPeriod"/>
              <a:defRPr/>
            </a:pPr>
            <a:r>
              <a:rPr lang="en-US"/>
              <a:t>Read depth distribution of all detected loci overlapped with WGS ground truth in </a:t>
            </a:r>
            <a:r>
              <a:rPr lang="en-US" err="1"/>
              <a:t>snATAC</a:t>
            </a:r>
            <a:r>
              <a:rPr lang="en-US"/>
              <a:t> data.</a:t>
            </a:r>
            <a:endParaRPr lang="en-US">
              <a:solidFill>
                <a:srgbClr val="444444"/>
              </a:solidFill>
            </a:endParaRPr>
          </a:p>
          <a:p>
            <a:pPr marL="228600" indent="-228600">
              <a:buAutoNum type="alphaUcPeriod"/>
              <a:defRPr/>
            </a:pPr>
            <a:r>
              <a:rPr lang="en-US"/>
              <a:t>Read depth distribution of all detected loci by </a:t>
            </a:r>
            <a:r>
              <a:rPr lang="en-US" err="1"/>
              <a:t>Monopogen</a:t>
            </a:r>
            <a:r>
              <a:rPr lang="en-US"/>
              <a:t> overlapped with WGS ground truth in snRNA data.</a:t>
            </a:r>
            <a:endParaRPr lang="en-US">
              <a:solidFill>
                <a:srgbClr val="444444"/>
              </a:solidFill>
            </a:endParaRPr>
          </a:p>
          <a:p>
            <a:pPr marL="228600" indent="-228600">
              <a:buAutoNum type="alphaUcPeriod"/>
              <a:defRPr/>
            </a:pPr>
            <a:r>
              <a:rPr lang="en-US"/>
              <a:t>Read depth distribution of all detected loci by </a:t>
            </a:r>
            <a:r>
              <a:rPr lang="en-US" err="1"/>
              <a:t>Monopogen</a:t>
            </a:r>
            <a:r>
              <a:rPr lang="en-US"/>
              <a:t> overlapped with WGS ground truth in </a:t>
            </a:r>
            <a:r>
              <a:rPr lang="en-US" err="1"/>
              <a:t>snATAC</a:t>
            </a:r>
            <a:r>
              <a:rPr lang="en-US"/>
              <a:t> data.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04BBE3-9E74-CA05-7F48-3D44ED4BF88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1863C7-5195-9447-9340-D3FD109408A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1686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0D28720-1438-3FCC-E974-7762B16E2A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4B934360-9A62-0E7D-9F92-4908A6A275F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F81A07B-7967-CC46-50C7-827E83B22B7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N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: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ariant allele frequency features for donor specific SNVs for SComatic</a:t>
            </a:r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lele frequency for donor specific somatic SNVs called by SComatic. Allele frequencies were directly calculated from pileup files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/>
              <a:t>Allele frequency distribution of </a:t>
            </a:r>
            <a:r>
              <a:rPr lang="en-US" sz="1200" b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omatic</a:t>
            </a:r>
            <a:r>
              <a:rPr lang="en-US"/>
              <a:t> called HG02622 specific mutations in snRNA data. 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/>
              <a:t>Allele frequency distribution of </a:t>
            </a:r>
            <a:r>
              <a:rPr lang="en-US" sz="1200" b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omatic</a:t>
            </a:r>
            <a:r>
              <a:rPr lang="en-US"/>
              <a:t> called HG02622 specific mutations in snATAC data. 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/>
              <a:t>Allele frequency distribution of </a:t>
            </a:r>
            <a:r>
              <a:rPr lang="en-US" sz="1200" b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omatic</a:t>
            </a:r>
            <a:r>
              <a:rPr lang="en-US"/>
              <a:t> called HG02257 specific mutations in snRNA data. 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/>
              <a:t>Allele frequency distribution of </a:t>
            </a:r>
            <a:r>
              <a:rPr lang="en-US" sz="1200" b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omatic</a:t>
            </a:r>
            <a:r>
              <a:rPr lang="en-US"/>
              <a:t> called HG02257 specific mutations in snATAC data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/>
              <a:t>Allele frequency distribution of </a:t>
            </a:r>
            <a:r>
              <a:rPr lang="en-US" sz="1200" b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omatic</a:t>
            </a:r>
            <a:r>
              <a:rPr lang="en-US"/>
              <a:t> called HG00438 specific mutations in snRNA data. 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/>
              <a:t>Allele frequency distribution of </a:t>
            </a:r>
            <a:r>
              <a:rPr lang="en-US" sz="1200" b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omatic</a:t>
            </a:r>
            <a:r>
              <a:rPr lang="en-US"/>
              <a:t> called HG00438 specific mutations in snATAC data. </a:t>
            </a:r>
          </a:p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DD0EAE-68D0-61A6-D5E8-B98111E499E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1863C7-5195-9447-9340-D3FD109408A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3515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N" b="1"/>
              <a:t>Supplementary Figure 5:</a:t>
            </a:r>
            <a:r>
              <a:rPr lang="en-IN" b="1" dirty="0">
                <a:latin typeface="Aptos"/>
                <a:ea typeface="Calibri"/>
                <a:cs typeface="Calibri"/>
              </a:rPr>
              <a:t> </a:t>
            </a:r>
            <a:r>
              <a:rPr lang="en-US" b="1" dirty="0">
                <a:latin typeface="Calibri"/>
                <a:ea typeface="Calibri"/>
                <a:cs typeface="Calibri"/>
              </a:rPr>
              <a:t>Precision and Recall Stratified by Variant Type for snRNA-seq</a:t>
            </a:r>
          </a:p>
          <a:p>
            <a:pPr marL="228600" indent="-228600">
              <a:buAutoNum type="alphaUcPeriod"/>
            </a:pPr>
            <a:r>
              <a:rPr lang="en-US" dirty="0">
                <a:latin typeface="Calibri"/>
                <a:ea typeface="Calibri"/>
                <a:cs typeface="Calibri"/>
              </a:rPr>
              <a:t>Precision and recall change for germline mutations called by </a:t>
            </a:r>
            <a:r>
              <a:rPr lang="en-US" dirty="0" err="1">
                <a:latin typeface="Calibri"/>
                <a:ea typeface="Calibri"/>
                <a:cs typeface="Calibri"/>
              </a:rPr>
              <a:t>Monopogen</a:t>
            </a:r>
            <a:r>
              <a:rPr lang="en-US" dirty="0">
                <a:latin typeface="Calibri"/>
                <a:ea typeface="Calibri"/>
                <a:cs typeface="Calibri"/>
              </a:rPr>
              <a:t> in snRNA-seq data. The prevision for </a:t>
            </a:r>
            <a:r>
              <a:rPr lang="en-US" dirty="0" err="1">
                <a:latin typeface="Calibri"/>
                <a:ea typeface="Calibri"/>
                <a:cs typeface="Calibri"/>
              </a:rPr>
              <a:t>Monopogen</a:t>
            </a:r>
            <a:r>
              <a:rPr lang="en-US" dirty="0">
                <a:latin typeface="Calibri"/>
                <a:ea typeface="Calibri"/>
                <a:cs typeface="Calibri"/>
              </a:rPr>
              <a:t> germline variants is 1, because use used WGS to filter the reference data. </a:t>
            </a:r>
          </a:p>
          <a:p>
            <a:pPr marL="228600" indent="-228600">
              <a:buAutoNum type="alphaUcPeriod"/>
            </a:pPr>
            <a:r>
              <a:rPr lang="en-US" dirty="0"/>
              <a:t>Precision and recall change for somatic mutations called by </a:t>
            </a:r>
            <a:r>
              <a:rPr lang="en-US" dirty="0" err="1"/>
              <a:t>Monopogen</a:t>
            </a:r>
            <a:r>
              <a:rPr lang="en-US" dirty="0"/>
              <a:t> in snRNA-seq data.</a:t>
            </a:r>
          </a:p>
          <a:p>
            <a:pPr marL="228600" indent="-228600">
              <a:buAutoNum type="alphaUcPeriod"/>
            </a:pPr>
            <a:r>
              <a:rPr lang="en-US" dirty="0"/>
              <a:t>Precision and recall change for germline mutations called by  </a:t>
            </a:r>
            <a:r>
              <a:rPr lang="en-US" dirty="0" err="1"/>
              <a:t>SComatic</a:t>
            </a:r>
            <a:r>
              <a:rPr lang="en-US" dirty="0"/>
              <a:t> in snRNA-seq data.</a:t>
            </a:r>
          </a:p>
          <a:p>
            <a:pPr marL="228600" indent="-228600">
              <a:buAutoNum type="alphaUcPeriod"/>
            </a:pPr>
            <a:r>
              <a:rPr lang="en-US" dirty="0"/>
              <a:t>Precision and recall change for somatic mutations called by </a:t>
            </a:r>
            <a:r>
              <a:rPr lang="en-US" dirty="0" err="1"/>
              <a:t>SComatic</a:t>
            </a:r>
            <a:r>
              <a:rPr lang="en-US" dirty="0"/>
              <a:t> in snRNA-seq data.</a:t>
            </a:r>
            <a:endParaRPr lang="en-US" dirty="0">
              <a:latin typeface="Aptos"/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1863C7-5195-9447-9340-D3FD109408A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59764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E2D66D-B414-C89D-7236-3DD67462F32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420A324-B585-5E97-D9C2-BF5C9C7B30F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29BCD6DF-9ECF-E31E-A7C3-F40F6311708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N" b="1"/>
              <a:t>Supplementary Figure 6:</a:t>
            </a:r>
            <a:r>
              <a:rPr lang="en-IN" b="1" dirty="0">
                <a:latin typeface="Aptos"/>
                <a:ea typeface="Calibri"/>
                <a:cs typeface="Calibri"/>
              </a:rPr>
              <a:t> </a:t>
            </a:r>
            <a:r>
              <a:rPr lang="en-US" b="1" dirty="0">
                <a:latin typeface="Calibri"/>
                <a:ea typeface="Calibri"/>
                <a:cs typeface="Calibri"/>
              </a:rPr>
              <a:t>Precision and Recall Stratified by Variant Type for </a:t>
            </a:r>
            <a:r>
              <a:rPr lang="en-US" b="1" dirty="0" err="1">
                <a:latin typeface="Calibri"/>
                <a:ea typeface="Calibri"/>
                <a:cs typeface="Calibri"/>
              </a:rPr>
              <a:t>snATAC</a:t>
            </a:r>
            <a:r>
              <a:rPr lang="en-US" b="1" dirty="0">
                <a:latin typeface="Calibri"/>
                <a:ea typeface="Calibri"/>
                <a:cs typeface="Calibri"/>
              </a:rPr>
              <a:t>-seq</a:t>
            </a:r>
            <a:endParaRPr lang="en-US" b="1" dirty="0">
              <a:latin typeface="Aptos"/>
              <a:ea typeface="Calibri"/>
              <a:cs typeface="Calibri"/>
            </a:endParaRPr>
          </a:p>
          <a:p>
            <a:pPr marL="228600" indent="-228600">
              <a:buAutoNum type="alphaUcPeriod"/>
            </a:pPr>
            <a:r>
              <a:rPr lang="en-US">
                <a:latin typeface="Calibri"/>
                <a:ea typeface="Calibri"/>
                <a:cs typeface="Calibri"/>
              </a:rPr>
              <a:t>Precision and recall change for germline mutations called by </a:t>
            </a:r>
            <a:r>
              <a:rPr lang="en-US" err="1">
                <a:latin typeface="Calibri"/>
                <a:ea typeface="Calibri"/>
                <a:cs typeface="Calibri"/>
              </a:rPr>
              <a:t>Monopogen</a:t>
            </a:r>
            <a:r>
              <a:rPr lang="en-US">
                <a:latin typeface="Calibri"/>
                <a:ea typeface="Calibri"/>
                <a:cs typeface="Calibri"/>
              </a:rPr>
              <a:t> in </a:t>
            </a:r>
            <a:r>
              <a:rPr lang="en-US"/>
              <a:t>snATAC-seq</a:t>
            </a:r>
            <a:r>
              <a:rPr lang="en-US">
                <a:latin typeface="Calibri"/>
                <a:ea typeface="Calibri"/>
                <a:cs typeface="Calibri"/>
              </a:rPr>
              <a:t> data.</a:t>
            </a:r>
            <a:endParaRPr lang="en-US">
              <a:latin typeface="Aptos" panose="02110004020202020204"/>
              <a:ea typeface="Calibri"/>
              <a:cs typeface="Calibri"/>
            </a:endParaRPr>
          </a:p>
          <a:p>
            <a:pPr marL="228600" indent="-228600">
              <a:buAutoNum type="alphaUcPeriod"/>
            </a:pPr>
            <a:r>
              <a:rPr lang="en-US"/>
              <a:t>Precision and recall change for somatic mutations called by </a:t>
            </a:r>
            <a:r>
              <a:rPr lang="en-US" err="1"/>
              <a:t>Monopogen</a:t>
            </a:r>
            <a:r>
              <a:rPr lang="en-US"/>
              <a:t> in snATAC-seq data.</a:t>
            </a:r>
          </a:p>
          <a:p>
            <a:pPr marL="228600" indent="-228600">
              <a:buAutoNum type="alphaUcPeriod"/>
            </a:pPr>
            <a:r>
              <a:rPr lang="en-US"/>
              <a:t>Precision and recall change for germline mutations called by  </a:t>
            </a:r>
            <a:r>
              <a:rPr lang="en-US" err="1"/>
              <a:t>SComatic</a:t>
            </a:r>
            <a:r>
              <a:rPr lang="en-US"/>
              <a:t> in </a:t>
            </a:r>
            <a:r>
              <a:rPr lang="en-US" err="1"/>
              <a:t>snATAC</a:t>
            </a:r>
            <a:r>
              <a:rPr lang="en-US"/>
              <a:t>-seq data.</a:t>
            </a:r>
          </a:p>
          <a:p>
            <a:pPr marL="228600" indent="-228600">
              <a:buAutoNum type="alphaUcPeriod"/>
            </a:pPr>
            <a:r>
              <a:rPr lang="en-US"/>
              <a:t>Precision and recall change for somatic mutations called by </a:t>
            </a:r>
            <a:r>
              <a:rPr lang="en-US" err="1"/>
              <a:t>SComatic</a:t>
            </a:r>
            <a:r>
              <a:rPr lang="en-US"/>
              <a:t> in </a:t>
            </a:r>
            <a:r>
              <a:rPr lang="en-US" err="1"/>
              <a:t>snATAC</a:t>
            </a:r>
            <a:r>
              <a:rPr lang="en-US"/>
              <a:t>-seq data.</a:t>
            </a:r>
            <a:endParaRPr lang="en-US">
              <a:latin typeface="Aptos"/>
              <a:ea typeface="Calibri"/>
              <a:cs typeface="Calibri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82A9FA-6C5D-B298-D57E-F8B359E20FA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1863C7-5195-9447-9340-D3FD109408A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7463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A09AD4-952C-2576-0FE7-050AF83405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E7A0F2A-079D-9043-6073-7982BA7459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560D7E-98A0-6414-F8E0-0D88ECC545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299772-68B7-B751-9972-8AFC73FD8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7C07C3-7BCF-D190-160C-3BF0F6808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249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D9094D-DF25-CA0F-B4ED-23DD8A3A68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0175EF-CD68-C8E1-6D7B-2B1BC43B91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EAFE55-1DA5-3728-B77B-C608BAB54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0392F4-3058-672E-E52E-8B214F766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880A5-655B-ADEB-57B0-F75FC652F9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413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89AA739-D761-4682-A9C0-A9F93CB74C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C0A824-E2BE-2CFA-BEAF-D94C06E8A0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650AF5-2DAA-9E37-9E85-415E597A4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48618F-EFF6-8980-22CE-0CA1E0407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A0CAE0-5442-E19C-0D85-C6EC781D9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866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943011-5A11-31A8-8F90-DA273BB45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B8E27E-C53E-36B1-FD74-5A7B708479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765444-5441-95F0-20CE-9235152E4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097D5B-08F9-02A4-0F71-5F9F39727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784C5A-7EFB-03EA-2AD1-83E801CF4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240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45D52A-1609-17E4-072C-18C38EED15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83C841-2264-76F9-C9C4-D157414A39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8D57D-11D0-9FDA-0C4A-63FEE3DEB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1CDF38-DF52-6317-E0A4-2FC875A4C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1C162A-076B-3204-31A6-425EE79DDA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602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5C9919-E859-029D-9298-2162CDB37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826AFC-DE88-592E-D420-AA3A337A71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352017-D165-8A41-FE07-CAC746E001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C3ECC-BC64-64DA-FB2F-0C460E7C8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DEB095-2BCA-BB30-51BA-C1AC2EFE0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603A71-2BEF-BFB2-DB4F-9438CE37F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933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3DEF5-3438-DA6E-BD57-20808A962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7B044F-92E6-2098-62E0-CC66BEFF5E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1A0D57-8221-DDDD-80E9-98B978AAEE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050F1C-56E0-E529-C984-3FC39D64C7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020F6FC-A270-9B9B-A41E-E8443B84AA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898974-E52A-940A-192C-E354A78E55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5318E4-C8FE-23D0-B53A-A189CDD19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37B902-1C78-1D9A-F30A-66746BF14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482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88E987-0BB1-1AA6-9986-F9E8273298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856D08-F675-EFBC-C43C-637D4F0BA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956689-37CD-92CD-ADA6-3F20C6F34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1C87C44-0F9E-F492-4221-059CA7B24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758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3B0E964-15D7-340A-CCF3-A1C8E7BB7D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885D537-5716-9DAD-2EF5-440A56AE3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40A6EF-D2B3-0D21-66A6-EDB24C73F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269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4BACC-3EA0-DC24-DCDE-1B3539E00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D1E6AB-7740-A4BA-0455-C4675E1F20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28D3EE-4E4F-11AC-9DE3-D7109D274F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C9B4F5-8AC2-D393-9730-3C2D77B2B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70A265-F5B6-F0DD-55ED-6B2581D9B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A89D25-3BF9-2338-7F62-F199CF25E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825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DBC843-3AC0-5D48-D61C-D9E703D850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A63054-7EB9-5909-03E9-D833F8EE09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FC90C8-2B1B-8672-106C-6670312E4F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0B5D01-6079-6BF3-9938-B6F77D78D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DBD17A-7339-0C23-B188-10FADBD8B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F0B3B7-9B55-2C59-D45A-36C25341A8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675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E3D8A2-B5F4-F3EE-3960-F2ABF892A7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5C0419-B897-5247-2B9B-A8C6792381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FEDDC6-7DC9-0B2D-3D1C-B993E96682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DCF32D-172E-D04D-9B59-11081E197FEF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35866E-12EB-0C57-66F2-F4E18F226C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AC2DC7-C3F3-823B-2825-A287EF7419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A1C988-4B33-FF42-937D-A82245BEC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328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3FD1C90-777D-29A7-575B-A2C10E8A0C6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Google Shape;92;p1">
            <a:extLst>
              <a:ext uri="{FF2B5EF4-FFF2-40B4-BE49-F238E27FC236}">
                <a16:creationId xmlns:a16="http://schemas.microsoft.com/office/drawing/2014/main" id="{7A5CACB0-9635-99FB-DEC5-84C31BC5D98F}"/>
              </a:ext>
            </a:extLst>
          </p:cNvPr>
          <p:cNvSpPr txBox="1"/>
          <p:nvPr/>
        </p:nvSpPr>
        <p:spPr>
          <a:xfrm>
            <a:off x="2768139" y="307050"/>
            <a:ext cx="464397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ll genomic loci detected:</a:t>
            </a:r>
            <a:endParaRPr sz="105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0C49648-BCC9-0267-276F-7678BF2DFB78}"/>
              </a:ext>
            </a:extLst>
          </p:cNvPr>
          <p:cNvSpPr txBox="1"/>
          <p:nvPr/>
        </p:nvSpPr>
        <p:spPr>
          <a:xfrm>
            <a:off x="2968260" y="16834"/>
            <a:ext cx="609971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>
                <a:solidFill>
                  <a:schemeClr val="tx1"/>
                </a:solidFill>
              </a:rPr>
              <a:t>snRNA -seq:</a:t>
            </a:r>
            <a:endParaRPr lang="en-US" sz="1600"/>
          </a:p>
        </p:txBody>
      </p:sp>
      <p:pic>
        <p:nvPicPr>
          <p:cNvPr id="3" name="Picture 2" descr="A graph showing the size of a number of read depth&#10;&#10;AI-generated content may be incorrect.">
            <a:extLst>
              <a:ext uri="{FF2B5EF4-FFF2-40B4-BE49-F238E27FC236}">
                <a16:creationId xmlns:a16="http://schemas.microsoft.com/office/drawing/2014/main" id="{FF5D9891-DB8C-4907-35EA-FBB0C44643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7807" y="516607"/>
            <a:ext cx="4280002" cy="1973787"/>
          </a:xfrm>
          <a:prstGeom prst="rect">
            <a:avLst/>
          </a:prstGeom>
        </p:spPr>
      </p:pic>
      <p:pic>
        <p:nvPicPr>
          <p:cNvPr id="5" name="Picture 4" descr="A graph showing a number of data&#10;&#10;AI-generated content may be incorrect.">
            <a:extLst>
              <a:ext uri="{FF2B5EF4-FFF2-40B4-BE49-F238E27FC236}">
                <a16:creationId xmlns:a16="http://schemas.microsoft.com/office/drawing/2014/main" id="{83229764-E920-A5F9-7427-F935D8CB93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0096" y="2674793"/>
            <a:ext cx="4280002" cy="197378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4A9612F-BA15-2566-EB4F-2C6B71B81134}"/>
              </a:ext>
            </a:extLst>
          </p:cNvPr>
          <p:cNvSpPr txBox="1"/>
          <p:nvPr/>
        </p:nvSpPr>
        <p:spPr>
          <a:xfrm>
            <a:off x="7992550" y="16834"/>
            <a:ext cx="609971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err="1">
                <a:solidFill>
                  <a:schemeClr val="tx1"/>
                </a:solidFill>
              </a:rPr>
              <a:t>snATAC</a:t>
            </a:r>
            <a:r>
              <a:rPr lang="en-US" sz="1600" b="1">
                <a:solidFill>
                  <a:schemeClr val="tx1"/>
                </a:solidFill>
              </a:rPr>
              <a:t>-seq:</a:t>
            </a:r>
            <a:endParaRPr lang="en-US" sz="1600"/>
          </a:p>
        </p:txBody>
      </p:sp>
      <p:sp>
        <p:nvSpPr>
          <p:cNvPr id="13" name="Google Shape;92;p1">
            <a:extLst>
              <a:ext uri="{FF2B5EF4-FFF2-40B4-BE49-F238E27FC236}">
                <a16:creationId xmlns:a16="http://schemas.microsoft.com/office/drawing/2014/main" id="{9451DA33-B35F-F648-6CBC-36AAC1006F06}"/>
              </a:ext>
            </a:extLst>
          </p:cNvPr>
          <p:cNvSpPr txBox="1"/>
          <p:nvPr/>
        </p:nvSpPr>
        <p:spPr>
          <a:xfrm>
            <a:off x="2813859" y="2440878"/>
            <a:ext cx="464397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ll detected loci in ground truth:</a:t>
            </a:r>
            <a:endParaRPr sz="1050"/>
          </a:p>
        </p:txBody>
      </p:sp>
      <p:sp>
        <p:nvSpPr>
          <p:cNvPr id="14" name="Google Shape;92;p1">
            <a:extLst>
              <a:ext uri="{FF2B5EF4-FFF2-40B4-BE49-F238E27FC236}">
                <a16:creationId xmlns:a16="http://schemas.microsoft.com/office/drawing/2014/main" id="{35E4C62B-EEA1-897B-B316-7E053684C346}"/>
              </a:ext>
            </a:extLst>
          </p:cNvPr>
          <p:cNvSpPr txBox="1"/>
          <p:nvPr/>
        </p:nvSpPr>
        <p:spPr>
          <a:xfrm>
            <a:off x="2825289" y="4618284"/>
            <a:ext cx="464397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omatic mutations detected by </a:t>
            </a:r>
            <a:r>
              <a:rPr lang="en-US" sz="120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onopogen</a:t>
            </a: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</a:t>
            </a:r>
            <a:endParaRPr sz="1050"/>
          </a:p>
        </p:txBody>
      </p:sp>
      <p:pic>
        <p:nvPicPr>
          <p:cNvPr id="16" name="Picture 15" descr="A blue and white graph&#10;&#10;AI-generated content may be incorrect.">
            <a:extLst>
              <a:ext uri="{FF2B5EF4-FFF2-40B4-BE49-F238E27FC236}">
                <a16:creationId xmlns:a16="http://schemas.microsoft.com/office/drawing/2014/main" id="{AFA587A9-D014-FA3F-B306-B18E3E5CBEE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0096" y="4868819"/>
            <a:ext cx="4280002" cy="1973787"/>
          </a:xfrm>
          <a:prstGeom prst="rect">
            <a:avLst/>
          </a:prstGeom>
        </p:spPr>
      </p:pic>
      <p:sp>
        <p:nvSpPr>
          <p:cNvPr id="17" name="Google Shape;92;p1">
            <a:extLst>
              <a:ext uri="{FF2B5EF4-FFF2-40B4-BE49-F238E27FC236}">
                <a16:creationId xmlns:a16="http://schemas.microsoft.com/office/drawing/2014/main" id="{12630BF8-7984-473E-9787-2D1A76A9A94A}"/>
              </a:ext>
            </a:extLst>
          </p:cNvPr>
          <p:cNvSpPr txBox="1"/>
          <p:nvPr/>
        </p:nvSpPr>
        <p:spPr>
          <a:xfrm>
            <a:off x="7809090" y="307816"/>
            <a:ext cx="464397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ll genomic loci detected:</a:t>
            </a:r>
            <a:endParaRPr sz="1050"/>
          </a:p>
        </p:txBody>
      </p:sp>
      <p:sp>
        <p:nvSpPr>
          <p:cNvPr id="20" name="Google Shape;92;p1">
            <a:extLst>
              <a:ext uri="{FF2B5EF4-FFF2-40B4-BE49-F238E27FC236}">
                <a16:creationId xmlns:a16="http://schemas.microsoft.com/office/drawing/2014/main" id="{C19D1F34-8E03-599D-9766-B46DC37CE9C8}"/>
              </a:ext>
            </a:extLst>
          </p:cNvPr>
          <p:cNvSpPr txBox="1"/>
          <p:nvPr/>
        </p:nvSpPr>
        <p:spPr>
          <a:xfrm>
            <a:off x="7854810" y="2441644"/>
            <a:ext cx="464397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ll detected loci in ground truth:</a:t>
            </a:r>
            <a:endParaRPr sz="1050"/>
          </a:p>
        </p:txBody>
      </p:sp>
      <p:sp>
        <p:nvSpPr>
          <p:cNvPr id="21" name="Google Shape;92;p1">
            <a:extLst>
              <a:ext uri="{FF2B5EF4-FFF2-40B4-BE49-F238E27FC236}">
                <a16:creationId xmlns:a16="http://schemas.microsoft.com/office/drawing/2014/main" id="{3CB3D0A9-A23D-CD9C-7E3B-41CC9F9099A1}"/>
              </a:ext>
            </a:extLst>
          </p:cNvPr>
          <p:cNvSpPr txBox="1"/>
          <p:nvPr/>
        </p:nvSpPr>
        <p:spPr>
          <a:xfrm>
            <a:off x="7866240" y="4619050"/>
            <a:ext cx="464397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omatic mutations detected by </a:t>
            </a:r>
            <a:r>
              <a:rPr lang="en-US" sz="120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onopogen</a:t>
            </a: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</a:t>
            </a:r>
            <a:endParaRPr sz="1050"/>
          </a:p>
        </p:txBody>
      </p:sp>
      <p:pic>
        <p:nvPicPr>
          <p:cNvPr id="23" name="Picture 22" descr="A graph of a graph showing the size of a number of read depth&#10;&#10;AI-generated content may be incorrect.">
            <a:extLst>
              <a:ext uri="{FF2B5EF4-FFF2-40B4-BE49-F238E27FC236}">
                <a16:creationId xmlns:a16="http://schemas.microsoft.com/office/drawing/2014/main" id="{C7FC65B0-7034-FDA3-A735-9AAE0025008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23038" y="528037"/>
            <a:ext cx="4266570" cy="1967593"/>
          </a:xfrm>
          <a:prstGeom prst="rect">
            <a:avLst/>
          </a:prstGeom>
        </p:spPr>
      </p:pic>
      <p:pic>
        <p:nvPicPr>
          <p:cNvPr id="24" name="Picture 23" descr="A graph of a number of data&#10;&#10;AI-generated content may be incorrect.">
            <a:extLst>
              <a:ext uri="{FF2B5EF4-FFF2-40B4-BE49-F238E27FC236}">
                <a16:creationId xmlns:a16="http://schemas.microsoft.com/office/drawing/2014/main" id="{278BCB64-3CF2-8F1E-B52D-91900655F75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24452" y="4868819"/>
            <a:ext cx="4280003" cy="1973788"/>
          </a:xfrm>
          <a:prstGeom prst="rect">
            <a:avLst/>
          </a:prstGeom>
        </p:spPr>
      </p:pic>
      <p:pic>
        <p:nvPicPr>
          <p:cNvPr id="26" name="Picture 25" descr="A graph of a number of data&#10;&#10;AI-generated content may be incorrect.">
            <a:extLst>
              <a:ext uri="{FF2B5EF4-FFF2-40B4-BE49-F238E27FC236}">
                <a16:creationId xmlns:a16="http://schemas.microsoft.com/office/drawing/2014/main" id="{E77C6A46-2E61-D5BE-7A52-557C9321407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643881" y="2674793"/>
            <a:ext cx="4280002" cy="197378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5AFAB23-F681-9B34-FE15-74360D0315B6}"/>
              </a:ext>
            </a:extLst>
          </p:cNvPr>
          <p:cNvSpPr txBox="1"/>
          <p:nvPr/>
        </p:nvSpPr>
        <p:spPr>
          <a:xfrm>
            <a:off x="2454264" y="404138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>
                <a:solidFill>
                  <a:schemeClr val="tx1"/>
                </a:solidFill>
              </a:rPr>
              <a:t>A</a:t>
            </a:r>
            <a:endParaRPr lang="en-US" sz="200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DA31F1A-D90B-D65B-5F5F-CBAAC6ADB8C0}"/>
              </a:ext>
            </a:extLst>
          </p:cNvPr>
          <p:cNvSpPr txBox="1"/>
          <p:nvPr/>
        </p:nvSpPr>
        <p:spPr>
          <a:xfrm>
            <a:off x="7508449" y="383954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B</a:t>
            </a:r>
            <a:endParaRPr lang="en-US" sz="20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E4D2AAE-B127-0193-E2FD-38BDC2C1B93E}"/>
              </a:ext>
            </a:extLst>
          </p:cNvPr>
          <p:cNvSpPr txBox="1"/>
          <p:nvPr/>
        </p:nvSpPr>
        <p:spPr>
          <a:xfrm>
            <a:off x="2454263" y="2579357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C</a:t>
            </a:r>
            <a:endParaRPr lang="en-US" sz="20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7FA6E1C-98BF-5560-7710-0F534883C421}"/>
              </a:ext>
            </a:extLst>
          </p:cNvPr>
          <p:cNvSpPr txBox="1"/>
          <p:nvPr/>
        </p:nvSpPr>
        <p:spPr>
          <a:xfrm>
            <a:off x="7445891" y="2684511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D</a:t>
            </a:r>
            <a:endParaRPr lang="en-US" sz="200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01364C1-511C-6E26-00F3-922804DAB98F}"/>
              </a:ext>
            </a:extLst>
          </p:cNvPr>
          <p:cNvSpPr txBox="1"/>
          <p:nvPr/>
        </p:nvSpPr>
        <p:spPr>
          <a:xfrm>
            <a:off x="2484703" y="4754576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E</a:t>
            </a:r>
            <a:endParaRPr lang="en-US" sz="200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9A81E1-13CC-B4AE-3190-ECE1D84FBA79}"/>
              </a:ext>
            </a:extLst>
          </p:cNvPr>
          <p:cNvSpPr txBox="1"/>
          <p:nvPr/>
        </p:nvSpPr>
        <p:spPr>
          <a:xfrm>
            <a:off x="7469259" y="4892213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F</a:t>
            </a:r>
            <a:endParaRPr lang="en-US" sz="200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0C5DEB1-4D79-10D7-4C44-92ECA524A1E2}"/>
              </a:ext>
            </a:extLst>
          </p:cNvPr>
          <p:cNvSpPr txBox="1"/>
          <p:nvPr/>
        </p:nvSpPr>
        <p:spPr>
          <a:xfrm>
            <a:off x="280" y="-2756"/>
            <a:ext cx="3834521" cy="40011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000" b="1"/>
              <a:t>Supplementary Figure 1</a:t>
            </a:r>
            <a:endParaRPr lang="en-US" sz="2000"/>
          </a:p>
        </p:txBody>
      </p:sp>
    </p:spTree>
    <p:extLst>
      <p:ext uri="{BB962C8B-B14F-4D97-AF65-F5344CB8AC3E}">
        <p14:creationId xmlns:p14="http://schemas.microsoft.com/office/powerpoint/2010/main" val="5765129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05832CD-9C71-A4C1-6709-06C6068DB58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A78F037B-AD9C-422E-5A97-D209F4C40191}"/>
              </a:ext>
            </a:extLst>
          </p:cNvPr>
          <p:cNvSpPr txBox="1">
            <a:spLocks/>
          </p:cNvSpPr>
          <p:nvPr/>
        </p:nvSpPr>
        <p:spPr>
          <a:xfrm>
            <a:off x="2928822" y="84372"/>
            <a:ext cx="3039273" cy="7315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/>
              <a:t>snRNA-seq VAF</a:t>
            </a:r>
          </a:p>
        </p:txBody>
      </p:sp>
      <p:sp>
        <p:nvSpPr>
          <p:cNvPr id="37" name="Title 1">
            <a:extLst>
              <a:ext uri="{FF2B5EF4-FFF2-40B4-BE49-F238E27FC236}">
                <a16:creationId xmlns:a16="http://schemas.microsoft.com/office/drawing/2014/main" id="{F5B791B8-4A44-434E-DEB2-F7849FF30E6B}"/>
              </a:ext>
            </a:extLst>
          </p:cNvPr>
          <p:cNvSpPr txBox="1">
            <a:spLocks/>
          </p:cNvSpPr>
          <p:nvPr/>
        </p:nvSpPr>
        <p:spPr>
          <a:xfrm>
            <a:off x="8205602" y="88082"/>
            <a:ext cx="3039273" cy="7315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err="1"/>
              <a:t>snATAC</a:t>
            </a:r>
            <a:r>
              <a:rPr lang="en-US" sz="2000"/>
              <a:t>-seq VAF</a:t>
            </a:r>
          </a:p>
        </p:txBody>
      </p:sp>
      <p:sp>
        <p:nvSpPr>
          <p:cNvPr id="48" name="Title 1">
            <a:extLst>
              <a:ext uri="{FF2B5EF4-FFF2-40B4-BE49-F238E27FC236}">
                <a16:creationId xmlns:a16="http://schemas.microsoft.com/office/drawing/2014/main" id="{1F7A509F-F554-A02B-CB85-9850DE97CEDD}"/>
              </a:ext>
            </a:extLst>
          </p:cNvPr>
          <p:cNvSpPr txBox="1">
            <a:spLocks/>
          </p:cNvSpPr>
          <p:nvPr/>
        </p:nvSpPr>
        <p:spPr>
          <a:xfrm>
            <a:off x="11391756" y="1307263"/>
            <a:ext cx="3039273" cy="7315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/>
              <a:t>10%</a:t>
            </a:r>
          </a:p>
        </p:txBody>
      </p:sp>
      <p:sp>
        <p:nvSpPr>
          <p:cNvPr id="49" name="Title 1">
            <a:extLst>
              <a:ext uri="{FF2B5EF4-FFF2-40B4-BE49-F238E27FC236}">
                <a16:creationId xmlns:a16="http://schemas.microsoft.com/office/drawing/2014/main" id="{2F507450-9475-797D-4D0D-627AB35583CF}"/>
              </a:ext>
            </a:extLst>
          </p:cNvPr>
          <p:cNvSpPr txBox="1">
            <a:spLocks/>
          </p:cNvSpPr>
          <p:nvPr/>
        </p:nvSpPr>
        <p:spPr>
          <a:xfrm>
            <a:off x="11461984" y="3352030"/>
            <a:ext cx="3039273" cy="7315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/>
              <a:t>2%</a:t>
            </a:r>
          </a:p>
        </p:txBody>
      </p:sp>
      <p:sp>
        <p:nvSpPr>
          <p:cNvPr id="50" name="Title 1">
            <a:extLst>
              <a:ext uri="{FF2B5EF4-FFF2-40B4-BE49-F238E27FC236}">
                <a16:creationId xmlns:a16="http://schemas.microsoft.com/office/drawing/2014/main" id="{7D841B72-2E66-EB2A-AF30-FBAB3B814317}"/>
              </a:ext>
            </a:extLst>
          </p:cNvPr>
          <p:cNvSpPr txBox="1">
            <a:spLocks/>
          </p:cNvSpPr>
          <p:nvPr/>
        </p:nvSpPr>
        <p:spPr>
          <a:xfrm>
            <a:off x="11391756" y="5394778"/>
            <a:ext cx="3039273" cy="7315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/>
              <a:t>0.5%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E8D3B3D-AF57-92F7-DCF3-7B0216E8D7A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1452392" y="4716571"/>
            <a:ext cx="4682396" cy="208621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EFA5BBD-D6E0-2793-95FF-C4D46D697C5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1392768" y="2670455"/>
            <a:ext cx="4729662" cy="209483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24943C7-D6E9-0C51-49EF-8F19AF216BCA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>
            <a:off x="1405123" y="615117"/>
            <a:ext cx="4682397" cy="210287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2EDBC1D-45B2-65DB-75B5-F6CD14C2EB85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/>
          <a:stretch/>
        </p:blipFill>
        <p:spPr>
          <a:xfrm>
            <a:off x="6813836" y="4730679"/>
            <a:ext cx="4672512" cy="211107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542FC6F-30F0-68A9-07BA-891914A45CB9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/>
          <a:stretch/>
        </p:blipFill>
        <p:spPr>
          <a:xfrm>
            <a:off x="6744329" y="2670442"/>
            <a:ext cx="4719780" cy="209045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EC3C248-312B-569B-7BA9-F1C1B543C537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6729646" y="623159"/>
            <a:ext cx="4664490" cy="209483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CFE00E5-9644-EAF4-B910-41ECE8E35595}"/>
              </a:ext>
            </a:extLst>
          </p:cNvPr>
          <p:cNvSpPr txBox="1"/>
          <p:nvPr/>
        </p:nvSpPr>
        <p:spPr>
          <a:xfrm>
            <a:off x="1253537" y="419532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>
                <a:solidFill>
                  <a:schemeClr val="tx1"/>
                </a:solidFill>
              </a:rPr>
              <a:t>A</a:t>
            </a:r>
            <a:endParaRPr lang="en-US" sz="200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FC98909-CD9F-09FD-98AE-A038EE58590E}"/>
              </a:ext>
            </a:extLst>
          </p:cNvPr>
          <p:cNvSpPr txBox="1"/>
          <p:nvPr/>
        </p:nvSpPr>
        <p:spPr>
          <a:xfrm>
            <a:off x="1253536" y="2594751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C</a:t>
            </a:r>
            <a:endParaRPr lang="en-US" sz="20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44BE38A-BA7D-C211-DE66-E108272EE3F0}"/>
              </a:ext>
            </a:extLst>
          </p:cNvPr>
          <p:cNvSpPr txBox="1"/>
          <p:nvPr/>
        </p:nvSpPr>
        <p:spPr>
          <a:xfrm>
            <a:off x="1283976" y="4769970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E</a:t>
            </a:r>
            <a:endParaRPr lang="en-US" sz="200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4C7F7FF-60CE-1CC2-517C-A53679D9308B}"/>
              </a:ext>
            </a:extLst>
          </p:cNvPr>
          <p:cNvSpPr txBox="1"/>
          <p:nvPr/>
        </p:nvSpPr>
        <p:spPr>
          <a:xfrm>
            <a:off x="6627838" y="419532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B</a:t>
            </a:r>
            <a:endParaRPr lang="en-US" sz="200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15E7B64-FD3C-481E-B13D-D2AFAA01C50C}"/>
              </a:ext>
            </a:extLst>
          </p:cNvPr>
          <p:cNvSpPr txBox="1"/>
          <p:nvPr/>
        </p:nvSpPr>
        <p:spPr>
          <a:xfrm>
            <a:off x="6565280" y="2720089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D</a:t>
            </a:r>
            <a:endParaRPr lang="en-US" sz="200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E34B87-FB3C-D40F-175A-EA19EB70402F}"/>
              </a:ext>
            </a:extLst>
          </p:cNvPr>
          <p:cNvSpPr txBox="1"/>
          <p:nvPr/>
        </p:nvSpPr>
        <p:spPr>
          <a:xfrm>
            <a:off x="6588648" y="4927791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F</a:t>
            </a:r>
            <a:endParaRPr lang="en-US" sz="200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FD1FFF-4095-AFB9-AABF-448D9A42E5E0}"/>
              </a:ext>
            </a:extLst>
          </p:cNvPr>
          <p:cNvSpPr txBox="1"/>
          <p:nvPr/>
        </p:nvSpPr>
        <p:spPr>
          <a:xfrm>
            <a:off x="280" y="-2756"/>
            <a:ext cx="3834521" cy="40011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000" b="1"/>
              <a:t>Supplementary Figure 2</a:t>
            </a:r>
            <a:endParaRPr lang="en-US" sz="2000"/>
          </a:p>
        </p:txBody>
      </p:sp>
    </p:spTree>
    <p:extLst>
      <p:ext uri="{BB962C8B-B14F-4D97-AF65-F5344CB8AC3E}">
        <p14:creationId xmlns:p14="http://schemas.microsoft.com/office/powerpoint/2010/main" val="29196165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9971AF9-37B0-D76E-2774-44BB826BB38E}"/>
              </a:ext>
            </a:extLst>
          </p:cNvPr>
          <p:cNvSpPr txBox="1"/>
          <p:nvPr/>
        </p:nvSpPr>
        <p:spPr>
          <a:xfrm>
            <a:off x="280" y="-2756"/>
            <a:ext cx="3834521" cy="40011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000" b="1" dirty="0"/>
              <a:t>Supplementary Figure 3</a:t>
            </a:r>
            <a:endParaRPr lang="en-US" sz="2000" dirty="0"/>
          </a:p>
        </p:txBody>
      </p:sp>
      <p:pic>
        <p:nvPicPr>
          <p:cNvPr id="7" name="Picture 6" descr="A graph with blue and orange lines&#10;&#10;AI-generated content may be incorrect.">
            <a:extLst>
              <a:ext uri="{FF2B5EF4-FFF2-40B4-BE49-F238E27FC236}">
                <a16:creationId xmlns:a16="http://schemas.microsoft.com/office/drawing/2014/main" id="{50503C12-9F1F-5090-E4F0-BA35214B6E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21495" y="548305"/>
            <a:ext cx="4926012" cy="277814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CD2F03D-425F-5D16-60CA-9D505587AB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4457" y="3530354"/>
            <a:ext cx="4925364" cy="292980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F21A4E5-F3A1-2F9F-0FBC-9B2FE057486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09587" y="3425141"/>
            <a:ext cx="5137301" cy="303934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C8136BD-106F-D484-28C8-F5B1B4FB5A37}"/>
              </a:ext>
            </a:extLst>
          </p:cNvPr>
          <p:cNvSpPr txBox="1"/>
          <p:nvPr/>
        </p:nvSpPr>
        <p:spPr>
          <a:xfrm>
            <a:off x="-4686" y="539382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>
                <a:solidFill>
                  <a:schemeClr val="tx1"/>
                </a:solidFill>
              </a:rPr>
              <a:t>A</a:t>
            </a:r>
            <a:endParaRPr lang="en-US" sz="200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14D418F-A49C-5A75-E246-3B0A35C6F53F}"/>
              </a:ext>
            </a:extLst>
          </p:cNvPr>
          <p:cNvSpPr txBox="1"/>
          <p:nvPr/>
        </p:nvSpPr>
        <p:spPr>
          <a:xfrm>
            <a:off x="5564886" y="541249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B</a:t>
            </a:r>
            <a:endParaRPr lang="en-US" sz="200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721EEA1-E6CF-08D5-17FD-688FEC8E6016}"/>
              </a:ext>
            </a:extLst>
          </p:cNvPr>
          <p:cNvSpPr txBox="1"/>
          <p:nvPr/>
        </p:nvSpPr>
        <p:spPr>
          <a:xfrm>
            <a:off x="-15125" y="3524751"/>
            <a:ext cx="487419" cy="40011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000" b="1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69D78B4-F786-646D-6732-4973C4B1A9CD}"/>
              </a:ext>
            </a:extLst>
          </p:cNvPr>
          <p:cNvSpPr txBox="1"/>
          <p:nvPr/>
        </p:nvSpPr>
        <p:spPr>
          <a:xfrm>
            <a:off x="5554447" y="3526619"/>
            <a:ext cx="487419" cy="40011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000" b="1"/>
              <a:t>D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1B415D17-FD12-4928-2F05-04A0F9E3D88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4016" y="546100"/>
            <a:ext cx="4929468" cy="2781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15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E435F2-C7C9-3F3D-BD62-D5B60E07ED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7FF8C7A-C7C9-6A47-AB0E-3536E50DDBB0}"/>
              </a:ext>
            </a:extLst>
          </p:cNvPr>
          <p:cNvSpPr txBox="1"/>
          <p:nvPr/>
        </p:nvSpPr>
        <p:spPr>
          <a:xfrm>
            <a:off x="280" y="-2756"/>
            <a:ext cx="3834521" cy="40011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000" b="1" dirty="0"/>
              <a:t>Supplementary Figure 4</a:t>
            </a:r>
            <a:endParaRPr lang="en-US" sz="2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9CA7A0D-B6F7-4373-6269-7ECAFA1BE88A}"/>
              </a:ext>
            </a:extLst>
          </p:cNvPr>
          <p:cNvSpPr txBox="1"/>
          <p:nvPr/>
        </p:nvSpPr>
        <p:spPr>
          <a:xfrm>
            <a:off x="-4686" y="539382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>
                <a:solidFill>
                  <a:schemeClr val="tx1"/>
                </a:solidFill>
              </a:rPr>
              <a:t>A</a:t>
            </a:r>
            <a:endParaRPr lang="en-US" sz="200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5B7CA2-326D-74C6-5E74-B74AD50FCC94}"/>
              </a:ext>
            </a:extLst>
          </p:cNvPr>
          <p:cNvSpPr txBox="1"/>
          <p:nvPr/>
        </p:nvSpPr>
        <p:spPr>
          <a:xfrm>
            <a:off x="5564886" y="541249"/>
            <a:ext cx="48741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/>
              <a:t>B</a:t>
            </a:r>
            <a:endParaRPr lang="en-US" sz="200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AE86E37-1524-A1C5-85BB-D733DB0B555A}"/>
              </a:ext>
            </a:extLst>
          </p:cNvPr>
          <p:cNvSpPr txBox="1"/>
          <p:nvPr/>
        </p:nvSpPr>
        <p:spPr>
          <a:xfrm>
            <a:off x="-15125" y="3524751"/>
            <a:ext cx="487419" cy="40011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000" b="1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DBB3896-C6B1-B88C-DC18-97A938D2C2DC}"/>
              </a:ext>
            </a:extLst>
          </p:cNvPr>
          <p:cNvSpPr txBox="1"/>
          <p:nvPr/>
        </p:nvSpPr>
        <p:spPr>
          <a:xfrm>
            <a:off x="5554447" y="3526619"/>
            <a:ext cx="487419" cy="40011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000" b="1"/>
              <a:t>D</a:t>
            </a:r>
          </a:p>
        </p:txBody>
      </p:sp>
      <p:pic>
        <p:nvPicPr>
          <p:cNvPr id="2" name="Picture 1" descr="A graph with a line and a line&#10;&#10;AI-generated content may be incorrect.">
            <a:extLst>
              <a:ext uri="{FF2B5EF4-FFF2-40B4-BE49-F238E27FC236}">
                <a16:creationId xmlns:a16="http://schemas.microsoft.com/office/drawing/2014/main" id="{89E46C3A-CD58-483B-ADDF-E08395429A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621" y="736169"/>
            <a:ext cx="4285024" cy="2505561"/>
          </a:xfrm>
          <a:prstGeom prst="rect">
            <a:avLst/>
          </a:prstGeom>
        </p:spPr>
      </p:pic>
      <p:pic>
        <p:nvPicPr>
          <p:cNvPr id="3" name="Picture 2" descr="A graph of a line&#10;&#10;AI-generated content may be incorrect.">
            <a:extLst>
              <a:ext uri="{FF2B5EF4-FFF2-40B4-BE49-F238E27FC236}">
                <a16:creationId xmlns:a16="http://schemas.microsoft.com/office/drawing/2014/main" id="{FED54664-55AB-2A9B-31C6-8B01910046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03911" y="736600"/>
            <a:ext cx="4276878" cy="2603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1641A64-94D9-1F71-33FF-22594E9E78A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4640" y="3525864"/>
            <a:ext cx="4294314" cy="2505561"/>
          </a:xfrm>
          <a:prstGeom prst="rect">
            <a:avLst/>
          </a:prstGeom>
        </p:spPr>
      </p:pic>
      <p:pic>
        <p:nvPicPr>
          <p:cNvPr id="10" name="Picture 9" descr="A graph with blue and orange lines&#10;&#10;AI-generated content may be incorrect.">
            <a:extLst>
              <a:ext uri="{FF2B5EF4-FFF2-40B4-BE49-F238E27FC236}">
                <a16:creationId xmlns:a16="http://schemas.microsoft.com/office/drawing/2014/main" id="{13B0F791-2427-FC56-D800-6CEE4B9F7C5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06064" y="3521344"/>
            <a:ext cx="4302709" cy="24947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2022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1</TotalTime>
  <Words>456</Words>
  <Application>Microsoft Macintosh PowerPoint</Application>
  <PresentationFormat>Widescreen</PresentationFormat>
  <Paragraphs>66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ang,Ziyi</dc:creator>
  <cp:lastModifiedBy>Rui Luo</cp:lastModifiedBy>
  <cp:revision>21</cp:revision>
  <dcterms:created xsi:type="dcterms:W3CDTF">2025-09-04T17:17:21Z</dcterms:created>
  <dcterms:modified xsi:type="dcterms:W3CDTF">2026-06-10T21:26:27Z</dcterms:modified>
</cp:coreProperties>
</file>